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 varScale="1">
        <p:scale>
          <a:sx n="165" d="100"/>
          <a:sy n="165" d="100"/>
        </p:scale>
        <p:origin x="150" y="8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VBoxSvr\Documents\article\2019\switchgrass_RNA-seq_YSA\sum-kan\Table_1_nbDEG+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VBoxSvr\Documents\article\2019\switchgrass_RNA-seq_YSA\sum-kan\Table_1_nbDEG+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Summer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Up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6:$B$8</c:f>
              <c:strCache>
                <c:ptCount val="3"/>
                <c:pt idx="0">
                  <c:v>D5</c:v>
                </c:pt>
                <c:pt idx="1">
                  <c:v>D10</c:v>
                </c:pt>
                <c:pt idx="2">
                  <c:v>D15</c:v>
                </c:pt>
              </c:strCache>
            </c:strRef>
          </c:cat>
          <c:val>
            <c:numRef>
              <c:f>Sheet1!$C$6:$C$8</c:f>
              <c:numCache>
                <c:formatCode>General</c:formatCode>
                <c:ptCount val="3"/>
                <c:pt idx="0">
                  <c:v>760</c:v>
                </c:pt>
                <c:pt idx="1">
                  <c:v>574</c:v>
                </c:pt>
                <c:pt idx="2">
                  <c:v>14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ABB-4AEB-8227-C8E74FA6CAA2}"/>
            </c:ext>
          </c:extLst>
        </c:ser>
        <c:ser>
          <c:idx val="1"/>
          <c:order val="1"/>
          <c:tx>
            <c:v>Down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6:$B$8</c:f>
              <c:strCache>
                <c:ptCount val="3"/>
                <c:pt idx="0">
                  <c:v>D5</c:v>
                </c:pt>
                <c:pt idx="1">
                  <c:v>D10</c:v>
                </c:pt>
                <c:pt idx="2">
                  <c:v>D15</c:v>
                </c:pt>
              </c:strCache>
            </c:strRef>
          </c:cat>
          <c:val>
            <c:numRef>
              <c:f>Sheet1!$D$6:$D$8</c:f>
              <c:numCache>
                <c:formatCode>General</c:formatCode>
                <c:ptCount val="3"/>
                <c:pt idx="0">
                  <c:v>818</c:v>
                </c:pt>
                <c:pt idx="1">
                  <c:v>33</c:v>
                </c:pt>
                <c:pt idx="2">
                  <c:v>3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ABB-4AEB-8227-C8E74FA6CA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0529384"/>
        <c:axId val="340529776"/>
      </c:barChart>
      <c:catAx>
        <c:axId val="340529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0529776"/>
        <c:crosses val="autoZero"/>
        <c:auto val="1"/>
        <c:lblAlgn val="ctr"/>
        <c:lblOffset val="100"/>
        <c:noMultiLvlLbl val="0"/>
      </c:catAx>
      <c:valAx>
        <c:axId val="3405297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#DEG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05293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Kanlow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2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3:$B$5</c:f>
              <c:strCache>
                <c:ptCount val="3"/>
                <c:pt idx="0">
                  <c:v>D5</c:v>
                </c:pt>
                <c:pt idx="1">
                  <c:v>D10</c:v>
                </c:pt>
                <c:pt idx="2">
                  <c:v>D15</c:v>
                </c:pt>
              </c:strCache>
            </c:strRef>
          </c:cat>
          <c:val>
            <c:numRef>
              <c:f>Sheet1!$C$3:$C$5</c:f>
              <c:numCache>
                <c:formatCode>General</c:formatCode>
                <c:ptCount val="3"/>
                <c:pt idx="0">
                  <c:v>110</c:v>
                </c:pt>
                <c:pt idx="1">
                  <c:v>55</c:v>
                </c:pt>
                <c:pt idx="2">
                  <c:v>3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08-44E6-AECE-A67A993EBE66}"/>
            </c:ext>
          </c:extLst>
        </c:ser>
        <c:ser>
          <c:idx val="1"/>
          <c:order val="1"/>
          <c:tx>
            <c:strRef>
              <c:f>Sheet1!$D$2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3:$B$5</c:f>
              <c:strCache>
                <c:ptCount val="3"/>
                <c:pt idx="0">
                  <c:v>D5</c:v>
                </c:pt>
                <c:pt idx="1">
                  <c:v>D10</c:v>
                </c:pt>
                <c:pt idx="2">
                  <c:v>D15</c:v>
                </c:pt>
              </c:strCache>
            </c:strRef>
          </c:cat>
          <c:val>
            <c:numRef>
              <c:f>Sheet1!$D$3:$D$5</c:f>
              <c:numCache>
                <c:formatCode>General</c:formatCode>
                <c:ptCount val="3"/>
                <c:pt idx="0">
                  <c:v>52</c:v>
                </c:pt>
                <c:pt idx="1">
                  <c:v>37</c:v>
                </c:pt>
                <c:pt idx="2">
                  <c:v>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408-44E6-AECE-A67A993EBE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9294064"/>
        <c:axId val="340528992"/>
      </c:barChart>
      <c:catAx>
        <c:axId val="339294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40528992"/>
        <c:crosses val="autoZero"/>
        <c:auto val="1"/>
        <c:lblAlgn val="ctr"/>
        <c:lblOffset val="100"/>
        <c:noMultiLvlLbl val="0"/>
      </c:catAx>
      <c:valAx>
        <c:axId val="3405289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#DEG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392940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326D2E-F9C2-4AE1-BCE0-6DA5D8E6B5AA}" type="datetimeFigureOut">
              <a:rPr lang="en-US" smtClean="0"/>
              <a:t>8/2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B356C4-5568-4276-9562-4B6A460EF3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5921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069933-154E-5F4B-A47B-E259B5F7360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0152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D9594-ACAB-440C-AFB4-7BB6ACFB8493}" type="datetimeFigureOut">
              <a:rPr lang="en-US" smtClean="0"/>
              <a:t>8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7F06D-1874-4456-90DE-20737570B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49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D9594-ACAB-440C-AFB4-7BB6ACFB8493}" type="datetimeFigureOut">
              <a:rPr lang="en-US" smtClean="0"/>
              <a:t>8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7F06D-1874-4456-90DE-20737570B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874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D9594-ACAB-440C-AFB4-7BB6ACFB8493}" type="datetimeFigureOut">
              <a:rPr lang="en-US" smtClean="0"/>
              <a:t>8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7F06D-1874-4456-90DE-20737570B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106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D9594-ACAB-440C-AFB4-7BB6ACFB8493}" type="datetimeFigureOut">
              <a:rPr lang="en-US" smtClean="0"/>
              <a:t>8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7F06D-1874-4456-90DE-20737570B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877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D9594-ACAB-440C-AFB4-7BB6ACFB8493}" type="datetimeFigureOut">
              <a:rPr lang="en-US" smtClean="0"/>
              <a:t>8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7F06D-1874-4456-90DE-20737570B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892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D9594-ACAB-440C-AFB4-7BB6ACFB8493}" type="datetimeFigureOut">
              <a:rPr lang="en-US" smtClean="0"/>
              <a:t>8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7F06D-1874-4456-90DE-20737570B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591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D9594-ACAB-440C-AFB4-7BB6ACFB8493}" type="datetimeFigureOut">
              <a:rPr lang="en-US" smtClean="0"/>
              <a:t>8/2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7F06D-1874-4456-90DE-20737570B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719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D9594-ACAB-440C-AFB4-7BB6ACFB8493}" type="datetimeFigureOut">
              <a:rPr lang="en-US" smtClean="0"/>
              <a:t>8/2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7F06D-1874-4456-90DE-20737570B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143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D9594-ACAB-440C-AFB4-7BB6ACFB8493}" type="datetimeFigureOut">
              <a:rPr lang="en-US" smtClean="0"/>
              <a:t>8/2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7F06D-1874-4456-90DE-20737570B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2447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D9594-ACAB-440C-AFB4-7BB6ACFB8493}" type="datetimeFigureOut">
              <a:rPr lang="en-US" smtClean="0"/>
              <a:t>8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7F06D-1874-4456-90DE-20737570B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857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D9594-ACAB-440C-AFB4-7BB6ACFB8493}" type="datetimeFigureOut">
              <a:rPr lang="en-US" smtClean="0"/>
              <a:t>8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E7F06D-1874-4456-90DE-20737570B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258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CD9594-ACAB-440C-AFB4-7BB6ACFB8493}" type="datetimeFigureOut">
              <a:rPr lang="en-US" smtClean="0"/>
              <a:t>8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E7F06D-1874-4456-90DE-20737570B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481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5784" y="1234415"/>
            <a:ext cx="194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066895" y="1255405"/>
            <a:ext cx="194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" name="Rectangle 2"/>
          <p:cNvSpPr/>
          <p:nvPr/>
        </p:nvSpPr>
        <p:spPr>
          <a:xfrm>
            <a:off x="4973" y="5711736"/>
            <a:ext cx="1212384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Global changes in DEGs.</a:t>
            </a:r>
          </a:p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DEGs up-regulated (blue) or down-regulated (orange) genes for each switchgrass genotype at 5 DAI, 10 DAI and 15 DAI of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YSA. 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ummer and B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nlow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aphicFrame>
        <p:nvGraphicFramePr>
          <p:cNvPr id="11" name="Chart 10"/>
          <p:cNvGraphicFramePr>
            <a:graphicFrameLocks/>
          </p:cNvGraphicFramePr>
          <p:nvPr/>
        </p:nvGraphicFramePr>
        <p:xfrm>
          <a:off x="597883" y="1347840"/>
          <a:ext cx="5303520" cy="3474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/>
        </p:nvGraphicFramePr>
        <p:xfrm>
          <a:off x="6428994" y="1329901"/>
          <a:ext cx="5303520" cy="3474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102565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5</Words>
  <Application>Microsoft Office PowerPoint</Application>
  <PresentationFormat>Widescreen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e</dc:creator>
  <cp:lastModifiedBy>Joe Louis</cp:lastModifiedBy>
  <cp:revision>2</cp:revision>
  <dcterms:created xsi:type="dcterms:W3CDTF">2020-08-20T14:28:34Z</dcterms:created>
  <dcterms:modified xsi:type="dcterms:W3CDTF">2020-08-27T20:23:10Z</dcterms:modified>
</cp:coreProperties>
</file>